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777" autoAdjust="0"/>
    <p:restoredTop sz="94660"/>
  </p:normalViewPr>
  <p:slideViewPr>
    <p:cSldViewPr>
      <p:cViewPr>
        <p:scale>
          <a:sx n="66" d="100"/>
          <a:sy n="66" d="100"/>
        </p:scale>
        <p:origin x="-3348" y="-1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793D4DE-A6B5-4475-8CE9-82A50DB52F3A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1C6B31-AAEC-4CBF-8CF1-C3A3D3ADCA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6360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upplementary figure 2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1C6B31-AAEC-4CBF-8CF1-C3A3D3ADCA2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341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0598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037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575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933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638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111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6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5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203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993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206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256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sidoli\Desktop\HeatMap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2102" r="81797"/>
          <a:stretch/>
        </p:blipFill>
        <p:spPr bwMode="auto">
          <a:xfrm>
            <a:off x="228600" y="277402"/>
            <a:ext cx="969196" cy="71139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 descr="C:\Users\sidoli\Desktop\HeatMap.pn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527" t="12102"/>
          <a:stretch/>
        </p:blipFill>
        <p:spPr bwMode="auto">
          <a:xfrm>
            <a:off x="3139611" y="277402"/>
            <a:ext cx="1569271" cy="71139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387"/>
          <a:stretch/>
        </p:blipFill>
        <p:spPr bwMode="auto">
          <a:xfrm>
            <a:off x="3500202" y="7691303"/>
            <a:ext cx="981075" cy="8328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131991" y="7747448"/>
            <a:ext cx="7340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-1.5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626527" y="7747448"/>
            <a:ext cx="7340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121062" y="7747448"/>
            <a:ext cx="7340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.5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635774" y="7494785"/>
            <a:ext cx="7340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Z-score</a:t>
            </a:r>
            <a:endParaRPr lang="en-US" sz="10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2883691" y="-259245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ESCs A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3129071" y="-259245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ESCs 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3145851" y="-487845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00nM JQ1 A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3391231" y="-487845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00nM JQ1 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3636611" y="-487845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00nM JQ1 A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3881993" y="-487845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00nM JQ1 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1119029" y="292813"/>
            <a:ext cx="2386170" cy="72019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EIAQDFKTDLR(H3 73-83) K79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YQKSTELLIR(H3 54-63) S57pr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QLATKAAR(H3 18-26) T22pr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QLATKAAR(H3 18-26) K18acT22pr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QLATKAAR(H3 18-26) K18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STGGVKKPHR(H33 27-40) K27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ATGGVKKPHR(H3 27-40) K27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ATGGVKKPHR(H3 27-40) K27me3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QLATKAAR(H3 18-26) K18me1K23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QLATKAAR(H3 18-26) T22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EIAQDFKTDLR(H3 73-83) K79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QLATKAAR(H3 18-26) K23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YQKSTELLIR(H3 54-63) Y54pr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VTIMPKDIQLAR(H3 117-128) M120ox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QLATKAAR(H3 18-26) K18acK23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YQKSTELLIR(H3 54-63) K56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TGGKAPR(H3 9-17) K9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ATGGVKKPHR(H3 27-40) K36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5acK12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5acK8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8acK12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TGGKAPR(H3 9-17) K9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8acK12acK16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QLATKAAR(H3 18-26) K23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TGGKAPR(H3 9-17) K9me3K14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TGGKAPR(H3 9-17) K9me2K14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5acK8acK12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TGGKAPR(H3 9-17) K9acK14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5acK8acK12acK16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STGGVKKPHR(H33 27-40) K27me3K36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12acK16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YQKSTELLIR(H3 54-63) K56me3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ATGGVKKPHR(H3 27-40) K27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5acK8acK16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STGGVKKPHR(H33 27-40) K27me3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16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EIAQDFKTDLR(H3 73-83) K79me3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TGGKAPR(H3 9-17) K9me1K14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VLR(H4 20-23) K20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VTIMPKDIQLAR(H3 117-128) K122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VLR(H4 20-23) K20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STGGVKKPHR(H33 27-40) K27me3K36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ATGGVKKPHR(H3 27-40) K27me3K36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ATGGVKKPHR(H3 27-40) K27me2K36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YQKSTELLIR(H3 54-63) K56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KQTAR(H3 3-8) K4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TGGKAPR(H3 9-17) K9me3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KQTAR(H3 3-8) K4me3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KQTAR(H3 3-8) K4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ATGGVKKPHR(H3 27-40) K27me2K36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STGGVKKPHR(H33 27-40) K27me2K36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8acK16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YQKSTELLIR(H3 54-63) K56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12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8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5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QLATKAAR(H3 18-26) K18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TGGKAPR(H3 9-17) K9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ATGGVKKPHR(H3 27-40) K27me1K36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ATGGVKKPHR(H3 27-40) K27me1K36me3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VLR(H4 20-23) K20me3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VLR(H4 20-23) K20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EIAQDFKTDLR(H3 73-83) K79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STGGVKKPHR(H33 27-40) K27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STGGVKKPHR(H33 27-40) K27me2K36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STGGVKKPHR(H33 27-40) K27me1K36me3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STGGVKKPHR(H33 27-40) K36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STGGVKKPHR(H33 27-40) K27me1K36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STGGVKKPHR(H33 27-40) K27me1K36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ATGGVKKPHR(H3 27-40) K27me1K36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5acK12acK16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KGGKGLGKGGAKR(H4 4-17) K5acK16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ATGGVKKPHR(H3 27-40) K36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STGGVKKPHR(H33 27-40) K36me2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APATGGVKKPHR(H3 27-40) K27me3K36me1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STGGKAPR(H3 9-17) K14ac</a:t>
            </a:r>
          </a:p>
          <a:p>
            <a:r>
              <a:rPr lang="en-US" sz="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KQTAR(H3 3-8) K4me1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61750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03</TotalTime>
  <Words>333</Words>
  <Application>Microsoft Office PowerPoint</Application>
  <PresentationFormat>On-screen Show (4:3)</PresentationFormat>
  <Paragraphs>8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e Sidoli</dc:creator>
  <cp:lastModifiedBy>Simone Sidoli</cp:lastModifiedBy>
  <cp:revision>86</cp:revision>
  <dcterms:created xsi:type="dcterms:W3CDTF">2015-05-05T20:17:23Z</dcterms:created>
  <dcterms:modified xsi:type="dcterms:W3CDTF">2015-09-01T13:40:30Z</dcterms:modified>
</cp:coreProperties>
</file>